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6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E1E873C9-324C-483B-B659-9442AC097CFB}" v="2" dt="2025-04-25T01:14:13.761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106" d="100"/>
          <a:sy n="106" d="100"/>
        </p:scale>
        <p:origin x="792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Natarajan, Purushothaman" userId="1457f158-7d29-4ac0-9a5f-3edc8e8ed731" providerId="ADAL" clId="{E1E873C9-324C-483B-B659-9442AC097CFB}"/>
    <pc:docChg chg="custSel modSld">
      <pc:chgData name="Natarajan, Purushothaman" userId="1457f158-7d29-4ac0-9a5f-3edc8e8ed731" providerId="ADAL" clId="{E1E873C9-324C-483B-B659-9442AC097CFB}" dt="2025-04-25T01:18:54.940" v="14" actId="20577"/>
      <pc:docMkLst>
        <pc:docMk/>
      </pc:docMkLst>
      <pc:sldChg chg="addSp delSp modSp mod setBg modClrScheme chgLayout">
        <pc:chgData name="Natarajan, Purushothaman" userId="1457f158-7d29-4ac0-9a5f-3edc8e8ed731" providerId="ADAL" clId="{E1E873C9-324C-483B-B659-9442AC097CFB}" dt="2025-04-25T01:18:54.940" v="14" actId="20577"/>
        <pc:sldMkLst>
          <pc:docMk/>
          <pc:sldMk cId="3359158246" sldId="256"/>
        </pc:sldMkLst>
        <pc:spChg chg="del">
          <ac:chgData name="Natarajan, Purushothaman" userId="1457f158-7d29-4ac0-9a5f-3edc8e8ed731" providerId="ADAL" clId="{E1E873C9-324C-483B-B659-9442AC097CFB}" dt="2025-04-25T01:13:29.068" v="0" actId="700"/>
          <ac:spMkLst>
            <pc:docMk/>
            <pc:sldMk cId="3359158246" sldId="256"/>
            <ac:spMk id="2" creationId="{2E65F4B2-A004-0A5F-C94D-33B7961AD16D}"/>
          </ac:spMkLst>
        </pc:spChg>
        <pc:spChg chg="del">
          <ac:chgData name="Natarajan, Purushothaman" userId="1457f158-7d29-4ac0-9a5f-3edc8e8ed731" providerId="ADAL" clId="{E1E873C9-324C-483B-B659-9442AC097CFB}" dt="2025-04-25T01:13:29.068" v="0" actId="700"/>
          <ac:spMkLst>
            <pc:docMk/>
            <pc:sldMk cId="3359158246" sldId="256"/>
            <ac:spMk id="3" creationId="{FBC4723C-181F-F633-5A77-6B3158338A3A}"/>
          </ac:spMkLst>
        </pc:spChg>
        <pc:spChg chg="add mod">
          <ac:chgData name="Natarajan, Purushothaman" userId="1457f158-7d29-4ac0-9a5f-3edc8e8ed731" providerId="ADAL" clId="{E1E873C9-324C-483B-B659-9442AC097CFB}" dt="2025-04-25T01:18:54.940" v="14" actId="20577"/>
          <ac:spMkLst>
            <pc:docMk/>
            <pc:sldMk cId="3359158246" sldId="256"/>
            <ac:spMk id="5" creationId="{8B426AB2-D3BA-85E4-95F5-2B4CC9E078A5}"/>
          </ac:spMkLst>
        </pc:spChg>
        <pc:picChg chg="add mod">
          <ac:chgData name="Natarajan, Purushothaman" userId="1457f158-7d29-4ac0-9a5f-3edc8e8ed731" providerId="ADAL" clId="{E1E873C9-324C-483B-B659-9442AC097CFB}" dt="2025-04-25T01:14:13.761" v="3" actId="1076"/>
          <ac:picMkLst>
            <pc:docMk/>
            <pc:sldMk cId="3359158246" sldId="256"/>
            <ac:picMk id="1026" creationId="{E561625C-88E5-79AD-1D62-CE7F80C3EB60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D6A18AC-0D2C-07B7-7B9B-90AEEF8022A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425DD88-949C-948C-C0C6-7A31841DC3B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860C6EE-6C57-EC0E-AF3C-2E2A364059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954277-B65A-41AE-A05F-CDD9DECD7869}" type="datetimeFigureOut">
              <a:rPr lang="en-US" smtClean="0"/>
              <a:t>5/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92E98FB-BF67-EDFB-1F5B-075A86ED70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211FF43-EEFD-F275-2C01-9DB4A7EA47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635BDE-3A5F-47D5-AEBF-C58177DDE9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7000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1ED5B59-CEFE-6BEA-5EF9-95A89074534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17C3E9D-7EE7-84C5-D738-49C8ABFAFDC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4A90588-1C9A-A348-4335-91E51C3506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954277-B65A-41AE-A05F-CDD9DECD7869}" type="datetimeFigureOut">
              <a:rPr lang="en-US" smtClean="0"/>
              <a:t>5/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185C0CF-23B6-0460-37B3-06B1096920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7F7575B-BA87-BFB2-A5C5-9B4A3FB6FA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635BDE-3A5F-47D5-AEBF-C58177DDE9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97726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68C2F87-9CDD-3306-E246-DE0E41553BB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FB28B5C-80C0-DD24-936B-A6F516781DD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A0A10F0-C15B-0579-81CC-5EACC29455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954277-B65A-41AE-A05F-CDD9DECD7869}" type="datetimeFigureOut">
              <a:rPr lang="en-US" smtClean="0"/>
              <a:t>5/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0158417-2D25-403C-AD9F-BBCF7BDC48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BC9FAE2-D8B0-873C-5A38-55E16E906D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635BDE-3A5F-47D5-AEBF-C58177DDE9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80319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7E20B76-ACA8-3236-509E-F179EB76391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38E4A80-58D8-7FBF-0DE0-23087FE708B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6BAE55D-7069-CDD6-0066-45CC6325AC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954277-B65A-41AE-A05F-CDD9DECD7869}" type="datetimeFigureOut">
              <a:rPr lang="en-US" smtClean="0"/>
              <a:t>5/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5D19E37-7253-E1F0-64B1-5A1594B2EB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56982CD-D4EE-92D3-6A00-6B0A851E0E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635BDE-3A5F-47D5-AEBF-C58177DDE9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80739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0614071-4358-CF5F-F06F-5B63ECBDB7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F955A0B-1AE7-BC56-8355-CE6BBC2490B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81F4D0F-41C3-8C96-9832-423A2CEB5A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954277-B65A-41AE-A05F-CDD9DECD7869}" type="datetimeFigureOut">
              <a:rPr lang="en-US" smtClean="0"/>
              <a:t>5/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E3E083F-D96A-B9DF-E4DD-71A32EFC9D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B6F1EE7-5625-7456-2D3E-6399BFCE41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635BDE-3A5F-47D5-AEBF-C58177DDE9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2216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8B4F2A-55FF-3DF9-7EFE-E34507BF530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8513AB8-4211-1B46-5984-E5DD54A5563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3F800A3-EB1E-7B7C-5857-62E57EF1C7E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9E77B25-F414-CB4E-4813-E16C6EE351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954277-B65A-41AE-A05F-CDD9DECD7869}" type="datetimeFigureOut">
              <a:rPr lang="en-US" smtClean="0"/>
              <a:t>5/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67084A6-D4EC-BC22-9215-4FDE83FA06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106C64A-0FFC-5BB5-A747-3CE66E6273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635BDE-3A5F-47D5-AEBF-C58177DDE9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7918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56E1B5-41B7-7BE7-AF66-1E11896D39B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6CDEDE6-2BEF-4173-F8B0-8DC815CCCA1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39B50EB-58C4-52DA-1AF3-53E64243261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ED9B960-998D-2041-5201-84E59C7F6C6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345048C-A692-BFB9-7542-5ACE7E9764E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7EFF1BD-2E10-78B9-3D98-CC02456460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954277-B65A-41AE-A05F-CDD9DECD7869}" type="datetimeFigureOut">
              <a:rPr lang="en-US" smtClean="0"/>
              <a:t>5/8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541316F-84D5-D73A-8D24-67C74F1D79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8CCADD3-1841-CD29-DC69-0DEE4C3C60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635BDE-3A5F-47D5-AEBF-C58177DDE9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41080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339DAB-3DB7-BFAE-6637-D1F45AA280F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FE51AF8-1A13-3D97-1A19-BF56A0FF38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954277-B65A-41AE-A05F-CDD9DECD7869}" type="datetimeFigureOut">
              <a:rPr lang="en-US" smtClean="0"/>
              <a:t>5/8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1CC1E30-8BCF-FDCE-E979-83D67636AB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8CF7F4F-B92A-666A-EC9D-801E404705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635BDE-3A5F-47D5-AEBF-C58177DDE9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66452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8E8C208-88FA-D336-7CE5-C5A667C5CD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954277-B65A-41AE-A05F-CDD9DECD7869}" type="datetimeFigureOut">
              <a:rPr lang="en-US" smtClean="0"/>
              <a:t>5/8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664C0D2-AF72-8CE7-321F-A85D22A86F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82A7CD8-287B-4BDD-DFFF-4DC3FE8E6B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635BDE-3A5F-47D5-AEBF-C58177DDE9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19295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ABB7BE-A4AA-AFA8-8745-25545C7C6D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2C287E8-B386-CE4F-501E-66DD406B7B0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C729216-4938-CB29-5FD8-C8B1138536E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9C46167-BA41-2510-3153-523476CAF1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954277-B65A-41AE-A05F-CDD9DECD7869}" type="datetimeFigureOut">
              <a:rPr lang="en-US" smtClean="0"/>
              <a:t>5/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95523EE-8EC3-1B00-A7B3-A67C73FCD5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88F11B2-C9D8-AE5E-E463-8909CEF13D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635BDE-3A5F-47D5-AEBF-C58177DDE9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13713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80837A-40C6-D24B-5C69-D38EF6B1DC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121DF83-3ED7-7A08-9D74-7E225B9DD3A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450BD82-D684-C31F-1CB5-A316F2D9B16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9E01E46-65C7-E4FC-284B-03F0736925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954277-B65A-41AE-A05F-CDD9DECD7869}" type="datetimeFigureOut">
              <a:rPr lang="en-US" smtClean="0"/>
              <a:t>5/8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5BE701D-D652-6E41-E846-99B880E43B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60CD1E4-2FEC-0F4A-59CE-E89C343D55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635BDE-3A5F-47D5-AEBF-C58177DDE9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36231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B8E5033-1325-2676-5AF1-09F33BDE82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004DC1A-0FC6-54EE-1B0C-4C71A167D65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DB77083-1E3C-5873-EF94-63F2A1DD929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9954277-B65A-41AE-A05F-CDD9DECD7869}" type="datetimeFigureOut">
              <a:rPr lang="en-US" smtClean="0"/>
              <a:t>5/8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D1CD9B6-2A6D-24B4-29E9-A4BE9A95A44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6FEE6C1-310F-C4C1-5C18-5B3B87D06F2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0635BDE-3A5F-47D5-AEBF-C58177DDE9C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51119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67664" y="1045029"/>
            <a:ext cx="6988647" cy="4167056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1896343" y="5427697"/>
            <a:ext cx="8637917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/>
              <a:t>Suppl. Figure S1: </a:t>
            </a:r>
            <a:r>
              <a:rPr lang="en-US" dirty="0"/>
              <a:t>Cell viability was assessed at 24 hours following treatment with various concentrations of curcumin, and the corresponding IC₅₀ value was determined based on the dose–response relationship</a:t>
            </a:r>
          </a:p>
        </p:txBody>
      </p:sp>
    </p:spTree>
    <p:extLst>
      <p:ext uri="{BB962C8B-B14F-4D97-AF65-F5344CB8AC3E}">
        <p14:creationId xmlns:p14="http://schemas.microsoft.com/office/powerpoint/2010/main" val="339794398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Plot object">
            <a:extLst>
              <a:ext uri="{FF2B5EF4-FFF2-40B4-BE49-F238E27FC236}">
                <a16:creationId xmlns:a16="http://schemas.microsoft.com/office/drawing/2014/main" id="{E561625C-88E5-79AD-1D62-CE7F80C3EB6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3070980" y="0"/>
            <a:ext cx="5571067" cy="5571067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8B426AB2-D3BA-85E4-95F5-2B4CC9E078A5}"/>
              </a:ext>
            </a:extLst>
          </p:cNvPr>
          <p:cNvSpPr txBox="1"/>
          <p:nvPr/>
        </p:nvSpPr>
        <p:spPr>
          <a:xfrm>
            <a:off x="1127760" y="5254443"/>
            <a:ext cx="10594848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b="1" dirty="0"/>
              <a:t>Suppl. </a:t>
            </a:r>
            <a:r>
              <a:rPr lang="en-US" b="1"/>
              <a:t>Figure S2</a:t>
            </a:r>
            <a:r>
              <a:rPr lang="en-US" b="1" dirty="0"/>
              <a:t>: X. Principal Component Analysis (PCA) of RNA-seq data</a:t>
            </a:r>
            <a:r>
              <a:rPr lang="en-US" dirty="0"/>
              <a:t>.</a:t>
            </a:r>
            <a:br>
              <a:rPr lang="en-US" dirty="0"/>
            </a:br>
            <a:r>
              <a:rPr lang="en-US" dirty="0"/>
              <a:t>PCA shows the variance in normalized gene expression profiles across samples. The first two principal components, PC1 and PC2, explain 85% and 5% of the total variance, respectively. Samples are color- and shape-coded by group: U87C (control) in red circles and U87T (treated) in cyan triangles.</a:t>
            </a:r>
          </a:p>
        </p:txBody>
      </p:sp>
    </p:spTree>
    <p:extLst>
      <p:ext uri="{BB962C8B-B14F-4D97-AF65-F5344CB8AC3E}">
        <p14:creationId xmlns:p14="http://schemas.microsoft.com/office/powerpoint/2010/main" val="33591582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112</Words>
  <Application>Microsoft Office PowerPoint</Application>
  <PresentationFormat>Widescreen</PresentationFormat>
  <Paragraphs>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ptos</vt:lpstr>
      <vt:lpstr>Aptos Display</vt:lpstr>
      <vt:lpstr>Arial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atarajan, Purushothaman</dc:creator>
  <cp:lastModifiedBy>MDPI</cp:lastModifiedBy>
  <cp:revision>3</cp:revision>
  <dcterms:created xsi:type="dcterms:W3CDTF">2025-04-25T01:12:44Z</dcterms:created>
  <dcterms:modified xsi:type="dcterms:W3CDTF">2025-05-08T07:04:27Z</dcterms:modified>
</cp:coreProperties>
</file>